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bin" ContentType="application/vnd.openxmlformats-officedocument.oleObject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5" r:id="rId3"/>
    <p:sldId id="268" r:id="rId4"/>
    <p:sldId id="269" r:id="rId5"/>
    <p:sldId id="270" r:id="rId6"/>
    <p:sldId id="272" r:id="rId7"/>
    <p:sldId id="271" r:id="rId8"/>
  </p:sldIdLst>
  <p:sldSz cx="6858000" cy="121920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97" userDrawn="1">
          <p15:clr>
            <a:srgbClr val="A4A3A4"/>
          </p15:clr>
        </p15:guide>
        <p15:guide id="2" pos="39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55" autoAdjust="0"/>
    <p:restoredTop sz="94660"/>
  </p:normalViewPr>
  <p:slideViewPr>
    <p:cSldViewPr snapToGrid="0">
      <p:cViewPr varScale="1">
        <p:scale>
          <a:sx n="64" d="100"/>
          <a:sy n="64" d="100"/>
        </p:scale>
        <p:origin x="3408" y="200"/>
      </p:cViewPr>
      <p:guideLst>
        <p:guide orient="horz" pos="4997"/>
        <p:guide pos="39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Relationship Id="rId3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Relationship Id="rId2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4" Type="http://schemas.openxmlformats.org/officeDocument/2006/relationships/image" Target="../media/image14.emf"/><Relationship Id="rId5" Type="http://schemas.openxmlformats.org/officeDocument/2006/relationships/image" Target="../media/image15.emf"/><Relationship Id="rId6" Type="http://schemas.openxmlformats.org/officeDocument/2006/relationships/image" Target="../media/image16.emf"/><Relationship Id="rId1" Type="http://schemas.openxmlformats.org/officeDocument/2006/relationships/image" Target="../media/image11.emf"/><Relationship Id="rId2" Type="http://schemas.openxmlformats.org/officeDocument/2006/relationships/image" Target="../media/image12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5" Type="http://schemas.openxmlformats.org/officeDocument/2006/relationships/image" Target="../media/image21.emf"/><Relationship Id="rId6" Type="http://schemas.openxmlformats.org/officeDocument/2006/relationships/image" Target="../media/image22.emf"/><Relationship Id="rId1" Type="http://schemas.openxmlformats.org/officeDocument/2006/relationships/image" Target="../media/image17.emf"/><Relationship Id="rId2" Type="http://schemas.openxmlformats.org/officeDocument/2006/relationships/image" Target="../media/image18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4" Type="http://schemas.openxmlformats.org/officeDocument/2006/relationships/image" Target="../media/image26.emf"/><Relationship Id="rId5" Type="http://schemas.openxmlformats.org/officeDocument/2006/relationships/image" Target="../media/image27.emf"/><Relationship Id="rId6" Type="http://schemas.openxmlformats.org/officeDocument/2006/relationships/image" Target="../media/image28.emf"/><Relationship Id="rId1" Type="http://schemas.openxmlformats.org/officeDocument/2006/relationships/image" Target="../media/image23.emf"/><Relationship Id="rId2" Type="http://schemas.openxmlformats.org/officeDocument/2006/relationships/image" Target="../media/image2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8613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2187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78129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18146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2880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16448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53141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2265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23337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50458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6802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920527-B4E5-40CD-A0F9-0D74227AD4FA}" type="datetimeFigureOut">
              <a:rPr lang="en-AU" smtClean="0"/>
              <a:t>19/5/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95FC2-BBD1-4867-9B3F-10A76CAB27C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50621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oleObject" Target="../embeddings/oleObject3.bin"/><Relationship Id="rId12" Type="http://schemas.openxmlformats.org/officeDocument/2006/relationships/image" Target="../media/image3.emf"/><Relationship Id="rId13" Type="http://schemas.openxmlformats.org/officeDocument/2006/relationships/image" Target="../media/image8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4.tiff"/><Relationship Id="rId4" Type="http://schemas.openxmlformats.org/officeDocument/2006/relationships/image" Target="../media/image5.tiff"/><Relationship Id="rId5" Type="http://schemas.openxmlformats.org/officeDocument/2006/relationships/image" Target="../media/image6.tiff"/><Relationship Id="rId6" Type="http://schemas.openxmlformats.org/officeDocument/2006/relationships/image" Target="../media/image7.tiff"/><Relationship Id="rId7" Type="http://schemas.openxmlformats.org/officeDocument/2006/relationships/oleObject" Target="../embeddings/oleObject1.bin"/><Relationship Id="rId8" Type="http://schemas.openxmlformats.org/officeDocument/2006/relationships/image" Target="../media/image1.emf"/><Relationship Id="rId9" Type="http://schemas.openxmlformats.org/officeDocument/2006/relationships/oleObject" Target="../embeddings/oleObject2.bin"/><Relationship Id="rId10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4" Type="http://schemas.openxmlformats.org/officeDocument/2006/relationships/image" Target="../media/image9.emf"/><Relationship Id="rId5" Type="http://schemas.openxmlformats.org/officeDocument/2006/relationships/image" Target="../media/image8.png"/><Relationship Id="rId6" Type="http://schemas.openxmlformats.org/officeDocument/2006/relationships/oleObject" Target="../embeddings/oleObject5.bin"/><Relationship Id="rId7" Type="http://schemas.openxmlformats.org/officeDocument/2006/relationships/image" Target="../media/image10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4.emf"/><Relationship Id="rId12" Type="http://schemas.openxmlformats.org/officeDocument/2006/relationships/oleObject" Target="../embeddings/oleObject10.bin"/><Relationship Id="rId13" Type="http://schemas.openxmlformats.org/officeDocument/2006/relationships/image" Target="../media/image15.emf"/><Relationship Id="rId14" Type="http://schemas.openxmlformats.org/officeDocument/2006/relationships/oleObject" Target="../embeddings/oleObject11.bin"/><Relationship Id="rId15" Type="http://schemas.openxmlformats.org/officeDocument/2006/relationships/image" Target="../media/image16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Relationship Id="rId3" Type="http://schemas.openxmlformats.org/officeDocument/2006/relationships/oleObject" Target="../embeddings/oleObject6.bin"/><Relationship Id="rId4" Type="http://schemas.openxmlformats.org/officeDocument/2006/relationships/image" Target="../media/image11.emf"/><Relationship Id="rId5" Type="http://schemas.openxmlformats.org/officeDocument/2006/relationships/oleObject" Target="../embeddings/oleObject7.bin"/><Relationship Id="rId6" Type="http://schemas.openxmlformats.org/officeDocument/2006/relationships/image" Target="../media/image12.emf"/><Relationship Id="rId7" Type="http://schemas.openxmlformats.org/officeDocument/2006/relationships/image" Target="../media/image8.png"/><Relationship Id="rId8" Type="http://schemas.openxmlformats.org/officeDocument/2006/relationships/oleObject" Target="../embeddings/oleObject8.bin"/><Relationship Id="rId9" Type="http://schemas.openxmlformats.org/officeDocument/2006/relationships/image" Target="../media/image13.emf"/><Relationship Id="rId10" Type="http://schemas.openxmlformats.org/officeDocument/2006/relationships/oleObject" Target="../embeddings/oleObject9.bin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0.emf"/><Relationship Id="rId12" Type="http://schemas.openxmlformats.org/officeDocument/2006/relationships/oleObject" Target="../embeddings/oleObject16.bin"/><Relationship Id="rId13" Type="http://schemas.openxmlformats.org/officeDocument/2006/relationships/image" Target="../media/image21.emf"/><Relationship Id="rId14" Type="http://schemas.openxmlformats.org/officeDocument/2006/relationships/oleObject" Target="../embeddings/oleObject17.bin"/><Relationship Id="rId15" Type="http://schemas.openxmlformats.org/officeDocument/2006/relationships/image" Target="../media/image22.emf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8.png"/><Relationship Id="rId4" Type="http://schemas.openxmlformats.org/officeDocument/2006/relationships/oleObject" Target="../embeddings/oleObject12.bin"/><Relationship Id="rId5" Type="http://schemas.openxmlformats.org/officeDocument/2006/relationships/image" Target="../media/image17.emf"/><Relationship Id="rId6" Type="http://schemas.openxmlformats.org/officeDocument/2006/relationships/oleObject" Target="../embeddings/oleObject13.bin"/><Relationship Id="rId7" Type="http://schemas.openxmlformats.org/officeDocument/2006/relationships/image" Target="../media/image18.emf"/><Relationship Id="rId8" Type="http://schemas.openxmlformats.org/officeDocument/2006/relationships/oleObject" Target="../embeddings/oleObject14.bin"/><Relationship Id="rId9" Type="http://schemas.openxmlformats.org/officeDocument/2006/relationships/image" Target="../media/image19.emf"/><Relationship Id="rId10" Type="http://schemas.openxmlformats.org/officeDocument/2006/relationships/oleObject" Target="../embeddings/oleObject15.bin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6.emf"/><Relationship Id="rId12" Type="http://schemas.openxmlformats.org/officeDocument/2006/relationships/oleObject" Target="../embeddings/oleObject22.bin"/><Relationship Id="rId13" Type="http://schemas.openxmlformats.org/officeDocument/2006/relationships/image" Target="../media/image27.emf"/><Relationship Id="rId14" Type="http://schemas.openxmlformats.org/officeDocument/2006/relationships/oleObject" Target="../embeddings/oleObject23.bin"/><Relationship Id="rId15" Type="http://schemas.openxmlformats.org/officeDocument/2006/relationships/image" Target="../media/image28.emf"/><Relationship Id="rId1" Type="http://schemas.openxmlformats.org/officeDocument/2006/relationships/vmlDrawing" Target="../drawings/vmlDrawing5.vml"/><Relationship Id="rId2" Type="http://schemas.openxmlformats.org/officeDocument/2006/relationships/slideLayout" Target="../slideLayouts/slideLayout2.xml"/><Relationship Id="rId3" Type="http://schemas.openxmlformats.org/officeDocument/2006/relationships/image" Target="../media/image8.png"/><Relationship Id="rId4" Type="http://schemas.openxmlformats.org/officeDocument/2006/relationships/oleObject" Target="../embeddings/oleObject18.bin"/><Relationship Id="rId5" Type="http://schemas.openxmlformats.org/officeDocument/2006/relationships/image" Target="../media/image23.emf"/><Relationship Id="rId6" Type="http://schemas.openxmlformats.org/officeDocument/2006/relationships/oleObject" Target="../embeddings/oleObject19.bin"/><Relationship Id="rId7" Type="http://schemas.openxmlformats.org/officeDocument/2006/relationships/image" Target="../media/image24.emf"/><Relationship Id="rId8" Type="http://schemas.openxmlformats.org/officeDocument/2006/relationships/oleObject" Target="../embeddings/oleObject20.bin"/><Relationship Id="rId9" Type="http://schemas.openxmlformats.org/officeDocument/2006/relationships/image" Target="../media/image25.emf"/><Relationship Id="rId10" Type="http://schemas.openxmlformats.org/officeDocument/2006/relationships/oleObject" Target="../embeddings/oleObject21.bin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261794" y="6782307"/>
            <a:ext cx="4424986" cy="3541310"/>
            <a:chOff x="1148154" y="7770566"/>
            <a:chExt cx="4424986" cy="3541310"/>
          </a:xfrm>
        </p:grpSpPr>
        <p:sp>
          <p:nvSpPr>
            <p:cNvPr id="5" name="TextBox 4"/>
            <p:cNvSpPr txBox="1"/>
            <p:nvPr/>
          </p:nvSpPr>
          <p:spPr>
            <a:xfrm rot="16200000">
              <a:off x="677181" y="10078158"/>
              <a:ext cx="13281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BPH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520020" y="8731209"/>
              <a:ext cx="1625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BPN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023337" y="7770567"/>
              <a:ext cx="1625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ontrol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947540" y="7770566"/>
              <a:ext cx="1625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Diabetic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9800" y="8117797"/>
              <a:ext cx="1902232" cy="14122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9595" y="8117796"/>
              <a:ext cx="1902232" cy="14266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6426" y="9581882"/>
              <a:ext cx="1882951" cy="14122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4287" y="9568870"/>
              <a:ext cx="1873268" cy="14225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1497303" y="11004099"/>
              <a:ext cx="23176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x 40 magnification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2165239" y="262483"/>
            <a:ext cx="23985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DAT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791476" y="140949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467595" y="3702519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15636" y="3687890"/>
            <a:ext cx="310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209302" y="6768946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03935" y="892237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1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4446641"/>
              </p:ext>
            </p:extLst>
          </p:nvPr>
        </p:nvGraphicFramePr>
        <p:xfrm>
          <a:off x="2030389" y="1336627"/>
          <a:ext cx="2932113" cy="2474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04" name="Prism 9" r:id="rId7" imgW="2931865" imgH="2474618" progId="Prism9.Document">
                  <p:embed/>
                </p:oleObj>
              </mc:Choice>
              <mc:Fallback>
                <p:oleObj name="Prism 9" r:id="rId7" imgW="2931865" imgH="247461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30389" y="1336627"/>
                        <a:ext cx="2932113" cy="2474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2093769"/>
              </p:ext>
            </p:extLst>
          </p:nvPr>
        </p:nvGraphicFramePr>
        <p:xfrm>
          <a:off x="3586518" y="3914265"/>
          <a:ext cx="3124200" cy="261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05" name="Prism 9" r:id="rId9" imgW="3123817" imgH="2616159" progId="Prism9.Document">
                  <p:embed/>
                </p:oleObj>
              </mc:Choice>
              <mc:Fallback>
                <p:oleObj name="Prism 9" r:id="rId9" imgW="3123817" imgH="261615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86518" y="3914265"/>
                        <a:ext cx="3124200" cy="2616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8903092"/>
              </p:ext>
            </p:extLst>
          </p:nvPr>
        </p:nvGraphicFramePr>
        <p:xfrm>
          <a:off x="333257" y="3932677"/>
          <a:ext cx="3214687" cy="2606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506" name="Prism 9" r:id="rId11" imgW="3215292" imgH="2607155" progId="Prism9.Document">
                  <p:embed/>
                </p:oleObj>
              </mc:Choice>
              <mc:Fallback>
                <p:oleObj name="Prism 9" r:id="rId11" imgW="3215292" imgH="26071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3257" y="3932677"/>
                        <a:ext cx="3214687" cy="2606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31" t="87102" b="3299"/>
          <a:stretch/>
        </p:blipFill>
        <p:spPr>
          <a:xfrm>
            <a:off x="1658915" y="1010820"/>
            <a:ext cx="3526971" cy="38001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sp>
        <p:nvSpPr>
          <p:cNvPr id="3" name="Rectangle 2"/>
          <p:cNvSpPr/>
          <p:nvPr/>
        </p:nvSpPr>
        <p:spPr>
          <a:xfrm>
            <a:off x="166255" y="10560292"/>
            <a:ext cx="656705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: </a:t>
            </a:r>
            <a:r>
              <a:rPr lang="en-GB" sz="1400" b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rdiomyocyte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 hypertrophy assessed with Haematoxylin and Eosin (H&amp;E) Staining.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(A) (A) </a:t>
            </a:r>
            <a:r>
              <a:rPr lang="en-GB" sz="1400" i="1" dirty="0">
                <a:latin typeface="Times New Roman" panose="02020603050405020304" pitchFamily="18" charset="0"/>
                <a:ea typeface="Calibri" panose="020F0502020204030204" pitchFamily="34" charset="0"/>
              </a:rPr>
              <a:t>βMHC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gene expression levels determined by </a:t>
            </a:r>
            <a:r>
              <a:rPr lang="en-GB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qRT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-PCR and expressed relative to non-diabetic BPN mice. (B) Quantification of </a:t>
            </a:r>
            <a:r>
              <a:rPr lang="en-GB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cardiomyocyte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area (µm</a:t>
            </a:r>
            <a:r>
              <a:rPr lang="en-GB" sz="14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) and (C) width (µm). (D) Representative images of H&amp;E stained sections were taken at 40x magnification (scale bar = 20μm). *P&lt;0.05 as indicated.  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Bars represent as mean ± SEM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individual values plotted. </a:t>
            </a:r>
            <a:endParaRPr lang="en-AU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5918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165239" y="262483"/>
            <a:ext cx="233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RY DAT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64178" y="631815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08383" y="172029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67595" y="1693546"/>
            <a:ext cx="310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3257154"/>
              </p:ext>
            </p:extLst>
          </p:nvPr>
        </p:nvGraphicFramePr>
        <p:xfrm>
          <a:off x="696060" y="1762196"/>
          <a:ext cx="3063875" cy="277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19" name="Prism 9" r:id="rId3" imgW="3064395" imgH="2771745" progId="Prism9.Document">
                  <p:embed/>
                </p:oleObj>
              </mc:Choice>
              <mc:Fallback>
                <p:oleObj name="Prism 9" r:id="rId3" imgW="3064395" imgH="277174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6060" y="1762196"/>
                        <a:ext cx="3063875" cy="277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31" t="87102" b="3299"/>
          <a:stretch/>
        </p:blipFill>
        <p:spPr>
          <a:xfrm>
            <a:off x="1645267" y="1201888"/>
            <a:ext cx="3526971" cy="38001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3877790"/>
              </p:ext>
            </p:extLst>
          </p:nvPr>
        </p:nvGraphicFramePr>
        <p:xfrm>
          <a:off x="3777302" y="1952125"/>
          <a:ext cx="293211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20" name="Prism 9" r:id="rId6" imgW="2931865" imgH="2497308" progId="Prism9.Document">
                  <p:embed/>
                </p:oleObj>
              </mc:Choice>
              <mc:Fallback>
                <p:oleObj name="Prism 9" r:id="rId6" imgW="2931865" imgH="249730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77302" y="1952125"/>
                        <a:ext cx="293211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538842" y="4807619"/>
            <a:ext cx="602821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2: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low cytometry data of the heart.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(A) Heart macrophage as a percentage of CD45+ leukocytes and (B) endothelial cells as a percentage of live cells. 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Bars represent as mean ± SEM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individual values plotted. </a:t>
            </a:r>
            <a:endParaRPr lang="en-AU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4418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65239" y="262483"/>
            <a:ext cx="233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RY DAT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4178" y="631815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77994" y="144445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69361" y="438823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356269" y="1442231"/>
            <a:ext cx="310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457516" y="4398215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3279" y="7911935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483549" y="7910747"/>
            <a:ext cx="209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F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4846221"/>
              </p:ext>
            </p:extLst>
          </p:nvPr>
        </p:nvGraphicFramePr>
        <p:xfrm>
          <a:off x="649286" y="1363897"/>
          <a:ext cx="3059113" cy="2611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" name="Prism 9" r:id="rId3" imgW="3059713" imgH="2611837" progId="Prism9.Document">
                  <p:embed/>
                </p:oleObj>
              </mc:Choice>
              <mc:Fallback>
                <p:oleObj name="Prism 9" r:id="rId3" imgW="3059713" imgH="261183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9286" y="1363897"/>
                        <a:ext cx="3059113" cy="2611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972676"/>
              </p:ext>
            </p:extLst>
          </p:nvPr>
        </p:nvGraphicFramePr>
        <p:xfrm>
          <a:off x="3611638" y="1350249"/>
          <a:ext cx="3063875" cy="2611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8" name="Prism 9" r:id="rId5" imgW="3064395" imgH="2611837" progId="Prism9.Document">
                  <p:embed/>
                </p:oleObj>
              </mc:Choice>
              <mc:Fallback>
                <p:oleObj name="Prism 9" r:id="rId5" imgW="3064395" imgH="261183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11638" y="1350249"/>
                        <a:ext cx="3063875" cy="2611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31" t="87102" b="3299"/>
          <a:stretch/>
        </p:blipFill>
        <p:spPr>
          <a:xfrm>
            <a:off x="1590676" y="874341"/>
            <a:ext cx="3526971" cy="38001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3770837"/>
              </p:ext>
            </p:extLst>
          </p:nvPr>
        </p:nvGraphicFramePr>
        <p:xfrm>
          <a:off x="619644" y="4308880"/>
          <a:ext cx="3105150" cy="308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9" name="Prism 9" r:id="rId8" imgW="3105450" imgH="3082919" progId="Prism9.Document">
                  <p:embed/>
                </p:oleObj>
              </mc:Choice>
              <mc:Fallback>
                <p:oleObj name="Prism 9" r:id="rId8" imgW="3105450" imgH="308291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19644" y="4308880"/>
                        <a:ext cx="3105150" cy="308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9050824"/>
              </p:ext>
            </p:extLst>
          </p:nvPr>
        </p:nvGraphicFramePr>
        <p:xfrm>
          <a:off x="3673071" y="4429197"/>
          <a:ext cx="2990850" cy="2922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900" name="Prism 9" r:id="rId10" imgW="2991287" imgH="2922650" progId="Prism9.Document">
                  <p:embed/>
                </p:oleObj>
              </mc:Choice>
              <mc:Fallback>
                <p:oleObj name="Prism 9" r:id="rId10" imgW="2991287" imgH="292265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73071" y="4429197"/>
                        <a:ext cx="2990850" cy="2922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53385075"/>
              </p:ext>
            </p:extLst>
          </p:nvPr>
        </p:nvGraphicFramePr>
        <p:xfrm>
          <a:off x="658292" y="7901177"/>
          <a:ext cx="3055937" cy="2611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901" name="Prism 9" r:id="rId12" imgW="3055391" imgH="2611837" progId="Prism9.Document">
                  <p:embed/>
                </p:oleObj>
              </mc:Choice>
              <mc:Fallback>
                <p:oleObj name="Prism 9" r:id="rId12" imgW="3055391" imgH="261183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58292" y="7901177"/>
                        <a:ext cx="3055937" cy="2611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7850872"/>
              </p:ext>
            </p:extLst>
          </p:nvPr>
        </p:nvGraphicFramePr>
        <p:xfrm>
          <a:off x="3636679" y="7985623"/>
          <a:ext cx="3051175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902" name="Prism 9" r:id="rId14" imgW="3050710" imgH="2497308" progId="Prism9.Document">
                  <p:embed/>
                </p:oleObj>
              </mc:Choice>
              <mc:Fallback>
                <p:oleObj name="Prism 9" r:id="rId14" imgW="3050710" imgH="249730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636679" y="7985623"/>
                        <a:ext cx="3051175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265709" y="10737825"/>
            <a:ext cx="646759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3: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low cytometry data of the spleen.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(A) Spleen total white blood cell (WBC) determined by </a:t>
            </a:r>
            <a:r>
              <a:rPr lang="en-GB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emavet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technology.  Number of (B) CD45+ leukocytes, (C) Lyc6+ monocytes, (D) neutrophils, (E) B cells and (F) T cells as quantified by flow cytometry. *P&lt;0.05, **P&lt;0.01, ***P&lt;0.001 and ****P&lt;0.0001 as indicated. 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Bars represent as mean ± SEM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individual values plotted. </a:t>
            </a:r>
            <a:endParaRPr lang="en-AU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14056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65239" y="262483"/>
            <a:ext cx="233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RY DAT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4178" y="631815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4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6982" y="157034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8959" y="467789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535257" y="1568120"/>
            <a:ext cx="310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17236" y="4667996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72877" y="7980166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563147" y="7980166"/>
            <a:ext cx="209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F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31" t="87102" b="3299"/>
          <a:stretch/>
        </p:blipFill>
        <p:spPr>
          <a:xfrm>
            <a:off x="1590676" y="874341"/>
            <a:ext cx="3526971" cy="38001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5391827"/>
              </p:ext>
            </p:extLst>
          </p:nvPr>
        </p:nvGraphicFramePr>
        <p:xfrm>
          <a:off x="699235" y="1696540"/>
          <a:ext cx="3055937" cy="252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3" name="Prism 9" r:id="rId4" imgW="3055391" imgH="2520358" progId="Prism9.Document">
                  <p:embed/>
                </p:oleObj>
              </mc:Choice>
              <mc:Fallback>
                <p:oleObj name="Prism 9" r:id="rId4" imgW="3055391" imgH="252035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99235" y="1696540"/>
                        <a:ext cx="3055937" cy="2520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4702827"/>
              </p:ext>
            </p:extLst>
          </p:nvPr>
        </p:nvGraphicFramePr>
        <p:xfrm>
          <a:off x="3573463" y="1694005"/>
          <a:ext cx="3284537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4" name="Prism 9" r:id="rId6" imgW="3284078" imgH="2497308" progId="Prism9.Document">
                  <p:embed/>
                </p:oleObj>
              </mc:Choice>
              <mc:Fallback>
                <p:oleObj name="Prism 9" r:id="rId6" imgW="3284078" imgH="249730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73463" y="1694005"/>
                        <a:ext cx="3284537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0807799"/>
              </p:ext>
            </p:extLst>
          </p:nvPr>
        </p:nvGraphicFramePr>
        <p:xfrm>
          <a:off x="602729" y="4737456"/>
          <a:ext cx="3167063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5" name="Prism 9" r:id="rId8" imgW="3166673" imgH="2497308" progId="Prism9.Document">
                  <p:embed/>
                </p:oleObj>
              </mc:Choice>
              <mc:Fallback>
                <p:oleObj name="Prism 9" r:id="rId8" imgW="3166673" imgH="249730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02729" y="4737456"/>
                        <a:ext cx="3167063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2775074"/>
              </p:ext>
            </p:extLst>
          </p:nvPr>
        </p:nvGraphicFramePr>
        <p:xfrm>
          <a:off x="3679825" y="4723808"/>
          <a:ext cx="3178175" cy="2497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6" name="Prism 9" r:id="rId10" imgW="3178918" imgH="2497308" progId="Prism9.Document">
                  <p:embed/>
                </p:oleObj>
              </mc:Choice>
              <mc:Fallback>
                <p:oleObj name="Prism 9" r:id="rId10" imgW="3178918" imgH="249730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79825" y="4723808"/>
                        <a:ext cx="3178175" cy="2497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9740046"/>
              </p:ext>
            </p:extLst>
          </p:nvPr>
        </p:nvGraphicFramePr>
        <p:xfrm>
          <a:off x="611991" y="8013102"/>
          <a:ext cx="3187700" cy="2719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7" name="Prism 8" r:id="rId12" imgW="3187921" imgH="2719883" progId="Prism8.Document">
                  <p:embed/>
                </p:oleObj>
              </mc:Choice>
              <mc:Fallback>
                <p:oleObj name="Prism 8" r:id="rId12" imgW="3187921" imgH="271988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11991" y="8013102"/>
                        <a:ext cx="3187700" cy="2719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733136"/>
              </p:ext>
            </p:extLst>
          </p:nvPr>
        </p:nvGraphicFramePr>
        <p:xfrm>
          <a:off x="3692525" y="8138391"/>
          <a:ext cx="3165475" cy="2563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8" name="Prism 8" r:id="rId14" imgW="3164873" imgH="2564297" progId="Prism8.Document">
                  <p:embed/>
                </p:oleObj>
              </mc:Choice>
              <mc:Fallback>
                <p:oleObj name="Prism 8" r:id="rId14" imgW="3164873" imgH="25642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692525" y="8138391"/>
                        <a:ext cx="3165475" cy="2563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Rectangle 9"/>
          <p:cNvSpPr/>
          <p:nvPr/>
        </p:nvSpPr>
        <p:spPr>
          <a:xfrm>
            <a:off x="314696" y="10848017"/>
            <a:ext cx="654330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4: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low cytometry data of the blood.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(A) Blood total white blood cell (WBC) determined by </a:t>
            </a:r>
            <a:r>
              <a:rPr lang="en-GB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emavet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technology.  Number of (B) CD45+ leukocytes, (C) Lyc6+ monocytes, (D) neutrophils, (E) B cells and (F) T cells as quantified by flow cytometry. **P&lt;0.01 and ****P&lt;0.0001 as indicated.   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Bars represent as mean ± SEM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individual values plotted. </a:t>
            </a:r>
            <a:endParaRPr lang="en-AU" sz="1400" dirty="0"/>
          </a:p>
        </p:txBody>
      </p:sp>
    </p:spTree>
    <p:extLst>
      <p:ext uri="{BB962C8B-B14F-4D97-AF65-F5344CB8AC3E}">
        <p14:creationId xmlns:p14="http://schemas.microsoft.com/office/powerpoint/2010/main" val="19533059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65239" y="262483"/>
            <a:ext cx="233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UPPLEMENTARY DAT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64178" y="631815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5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6982" y="157034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68837" y="467789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435867" y="1568120"/>
            <a:ext cx="3102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537114" y="4687874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72877" y="7730791"/>
            <a:ext cx="370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563147" y="7750669"/>
            <a:ext cx="209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F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31" t="87102" b="3299"/>
          <a:stretch/>
        </p:blipFill>
        <p:spPr>
          <a:xfrm>
            <a:off x="1590676" y="874341"/>
            <a:ext cx="3526971" cy="38001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6312377"/>
              </p:ext>
            </p:extLst>
          </p:nvPr>
        </p:nvGraphicFramePr>
        <p:xfrm>
          <a:off x="539338" y="1689966"/>
          <a:ext cx="3046413" cy="2660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3" name="Prism 8" r:id="rId4" imgW="3046028" imgH="2660458" progId="Prism8.Document">
                  <p:embed/>
                </p:oleObj>
              </mc:Choice>
              <mc:Fallback>
                <p:oleObj name="Prism 8" r:id="rId4" imgW="3046028" imgH="266045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9338" y="1689966"/>
                        <a:ext cx="3046413" cy="2660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6780042"/>
              </p:ext>
            </p:extLst>
          </p:nvPr>
        </p:nvGraphicFramePr>
        <p:xfrm>
          <a:off x="417224" y="4697990"/>
          <a:ext cx="3197225" cy="2962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4" name="Prism 8" r:id="rId6" imgW="3196925" imgH="2962267" progId="Prism8.Document">
                  <p:embed/>
                </p:oleObj>
              </mc:Choice>
              <mc:Fallback>
                <p:oleObj name="Prism 8" r:id="rId6" imgW="3196925" imgH="29622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17224" y="4697990"/>
                        <a:ext cx="3197225" cy="2962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8276310"/>
              </p:ext>
            </p:extLst>
          </p:nvPr>
        </p:nvGraphicFramePr>
        <p:xfrm>
          <a:off x="512227" y="8090896"/>
          <a:ext cx="3197225" cy="2563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5" name="Prism 8" r:id="rId8" imgW="3196925" imgH="2564297" progId="Prism8.Document">
                  <p:embed/>
                </p:oleObj>
              </mc:Choice>
              <mc:Fallback>
                <p:oleObj name="Prism 8" r:id="rId8" imgW="3196925" imgH="25642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2227" y="8090896"/>
                        <a:ext cx="3197225" cy="2563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5312008"/>
              </p:ext>
            </p:extLst>
          </p:nvPr>
        </p:nvGraphicFramePr>
        <p:xfrm>
          <a:off x="3614737" y="4962794"/>
          <a:ext cx="3243263" cy="267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6" name="Prism 8" r:id="rId10" imgW="3242662" imgH="2669822" progId="Prism8.Document">
                  <p:embed/>
                </p:oleObj>
              </mc:Choice>
              <mc:Fallback>
                <p:oleObj name="Prism 8" r:id="rId10" imgW="3242662" imgH="266982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14737" y="4962794"/>
                        <a:ext cx="3243263" cy="267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870934"/>
              </p:ext>
            </p:extLst>
          </p:nvPr>
        </p:nvGraphicFramePr>
        <p:xfrm>
          <a:off x="3767653" y="7662890"/>
          <a:ext cx="3192463" cy="2944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7" name="Prism 8" r:id="rId12" imgW="3192603" imgH="2944259" progId="Prism8.Document">
                  <p:embed/>
                </p:oleObj>
              </mc:Choice>
              <mc:Fallback>
                <p:oleObj name="Prism 8" r:id="rId12" imgW="3192603" imgH="294425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67653" y="7662890"/>
                        <a:ext cx="3192463" cy="2944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0452396"/>
              </p:ext>
            </p:extLst>
          </p:nvPr>
        </p:nvGraphicFramePr>
        <p:xfrm>
          <a:off x="3592513" y="1351499"/>
          <a:ext cx="3265487" cy="298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948" name="Prism 8" r:id="rId14" imgW="3265711" imgH="2980635" progId="Prism8.Document">
                  <p:embed/>
                </p:oleObj>
              </mc:Choice>
              <mc:Fallback>
                <p:oleObj name="Prism 8" r:id="rId14" imgW="3265711" imgH="29806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92513" y="1351499"/>
                        <a:ext cx="3265487" cy="298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194457" y="10773451"/>
            <a:ext cx="6550727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5: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low cytometry data of the bone marrow.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(A) Blood total white blood cell (WBC) determined by </a:t>
            </a:r>
            <a:r>
              <a:rPr lang="en-GB" sz="14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emavet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technology.  Number of (B) CD45+ leukocytes, (C) Lyc6+ monocytes, (D) neutrophils, (E) B cells and (F) T cells as quantified by flow cytometry. *P&lt;0.05, **P&lt;0.01, ***P&lt;0.001 and ****P&lt;0.0001 as indicated. </a:t>
            </a:r>
            <a:r>
              <a:rPr lang="en-AU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Bars represent as mean ± SEM 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individual values plotted. </a:t>
            </a:r>
            <a:endParaRPr lang="en-AU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95290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72EC37A9-E298-49F7-A543-5A0BDAEBBE55}"/>
              </a:ext>
            </a:extLst>
          </p:cNvPr>
          <p:cNvSpPr/>
          <p:nvPr/>
        </p:nvSpPr>
        <p:spPr>
          <a:xfrm>
            <a:off x="97362" y="8672113"/>
            <a:ext cx="655072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6: 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low </a:t>
            </a:r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diagram representing resistance to STZ treatment and mortality after STZ treatment in 3 cohorts of mice</a:t>
            </a:r>
            <a:r>
              <a:rPr lang="en-GB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. ND: non-diabetic and D: Diabetic.</a:t>
            </a:r>
            <a:endParaRPr lang="en-AU" sz="14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C9838433-4269-4833-97AB-79385B443273}"/>
              </a:ext>
            </a:extLst>
          </p:cNvPr>
          <p:cNvSpPr txBox="1"/>
          <p:nvPr/>
        </p:nvSpPr>
        <p:spPr>
          <a:xfrm>
            <a:off x="2551778" y="132736"/>
            <a:ext cx="1548581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/>
              <a:t>Cohort 1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xmlns="" id="{D546C77D-D2EA-435C-BE13-160AEC993F0B}"/>
              </a:ext>
            </a:extLst>
          </p:cNvPr>
          <p:cNvCxnSpPr>
            <a:cxnSpLocks/>
            <a:stCxn id="5" idx="2"/>
          </p:cNvCxnSpPr>
          <p:nvPr/>
        </p:nvCxnSpPr>
        <p:spPr>
          <a:xfrm>
            <a:off x="3326069" y="409735"/>
            <a:ext cx="0" cy="37131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xmlns="" id="{D37339EA-8242-405C-B26D-33D5D2681613}"/>
              </a:ext>
            </a:extLst>
          </p:cNvPr>
          <p:cNvCxnSpPr>
            <a:cxnSpLocks/>
          </p:cNvCxnSpPr>
          <p:nvPr/>
        </p:nvCxnSpPr>
        <p:spPr>
          <a:xfrm>
            <a:off x="638175" y="800100"/>
            <a:ext cx="54102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xmlns="" id="{DFEBC4A5-C218-4335-8838-C6078D988A6A}"/>
              </a:ext>
            </a:extLst>
          </p:cNvPr>
          <p:cNvCxnSpPr>
            <a:cxnSpLocks/>
          </p:cNvCxnSpPr>
          <p:nvPr/>
        </p:nvCxnSpPr>
        <p:spPr>
          <a:xfrm>
            <a:off x="630494" y="79734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1B6A2AC5-4C98-479B-BF15-56431427745A}"/>
              </a:ext>
            </a:extLst>
          </p:cNvPr>
          <p:cNvCxnSpPr>
            <a:cxnSpLocks/>
          </p:cNvCxnSpPr>
          <p:nvPr/>
        </p:nvCxnSpPr>
        <p:spPr>
          <a:xfrm>
            <a:off x="2344994" y="79734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EE66E623-52EB-4323-BA1C-7B246F60366D}"/>
              </a:ext>
            </a:extLst>
          </p:cNvPr>
          <p:cNvCxnSpPr>
            <a:cxnSpLocks/>
          </p:cNvCxnSpPr>
          <p:nvPr/>
        </p:nvCxnSpPr>
        <p:spPr>
          <a:xfrm>
            <a:off x="4335719" y="79734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xmlns="" id="{C46C5C89-6E6D-4B26-BC34-4BC7DEC7AF74}"/>
              </a:ext>
            </a:extLst>
          </p:cNvPr>
          <p:cNvCxnSpPr>
            <a:cxnSpLocks/>
          </p:cNvCxnSpPr>
          <p:nvPr/>
        </p:nvCxnSpPr>
        <p:spPr>
          <a:xfrm>
            <a:off x="6040694" y="79734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03C4CFC8-7144-498F-A235-C210BFBDF176}"/>
              </a:ext>
            </a:extLst>
          </p:cNvPr>
          <p:cNvSpPr txBox="1"/>
          <p:nvPr/>
        </p:nvSpPr>
        <p:spPr>
          <a:xfrm>
            <a:off x="161925" y="107632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ND BPN</a:t>
            </a:r>
          </a:p>
          <a:p>
            <a:pPr algn="ctr"/>
            <a:r>
              <a:rPr lang="en-AU" sz="1200" dirty="0"/>
              <a:t>n=9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A070D5A0-2BD6-4FDD-9449-F5C6DE9FA421}"/>
              </a:ext>
            </a:extLst>
          </p:cNvPr>
          <p:cNvSpPr txBox="1"/>
          <p:nvPr/>
        </p:nvSpPr>
        <p:spPr>
          <a:xfrm>
            <a:off x="1809750" y="1085850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D BPN</a:t>
            </a:r>
          </a:p>
          <a:p>
            <a:pPr algn="ctr"/>
            <a:r>
              <a:rPr lang="en-AU" sz="1200" dirty="0"/>
              <a:t>n=1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738C647C-6CF6-4ACC-B04C-251BB55B8BAF}"/>
              </a:ext>
            </a:extLst>
          </p:cNvPr>
          <p:cNvSpPr txBox="1"/>
          <p:nvPr/>
        </p:nvSpPr>
        <p:spPr>
          <a:xfrm>
            <a:off x="3819525" y="107632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ND BPH</a:t>
            </a:r>
          </a:p>
          <a:p>
            <a:pPr algn="ctr"/>
            <a:r>
              <a:rPr lang="en-AU" sz="1200" dirty="0"/>
              <a:t>n=7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15185EFE-D543-41DD-8096-202ADB7366E5}"/>
              </a:ext>
            </a:extLst>
          </p:cNvPr>
          <p:cNvSpPr txBox="1"/>
          <p:nvPr/>
        </p:nvSpPr>
        <p:spPr>
          <a:xfrm>
            <a:off x="5448300" y="107632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D BPH</a:t>
            </a:r>
          </a:p>
          <a:p>
            <a:pPr algn="ctr"/>
            <a:r>
              <a:rPr lang="en-AU" sz="1200" dirty="0"/>
              <a:t>n=13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xmlns="" id="{D15BA2FE-5900-42FC-B9AF-41BA64FD114B}"/>
              </a:ext>
            </a:extLst>
          </p:cNvPr>
          <p:cNvCxnSpPr>
            <a:cxnSpLocks/>
          </p:cNvCxnSpPr>
          <p:nvPr/>
        </p:nvCxnSpPr>
        <p:spPr>
          <a:xfrm>
            <a:off x="2344994" y="153076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xmlns="" id="{D8F452B8-ADAA-4208-8F71-67A6D6FA389F}"/>
              </a:ext>
            </a:extLst>
          </p:cNvPr>
          <p:cNvCxnSpPr>
            <a:cxnSpLocks/>
          </p:cNvCxnSpPr>
          <p:nvPr/>
        </p:nvCxnSpPr>
        <p:spPr>
          <a:xfrm>
            <a:off x="6059744" y="153076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16FDCFED-1725-4711-9428-22C535430F82}"/>
              </a:ext>
            </a:extLst>
          </p:cNvPr>
          <p:cNvSpPr txBox="1"/>
          <p:nvPr/>
        </p:nvSpPr>
        <p:spPr>
          <a:xfrm>
            <a:off x="1352550" y="1819275"/>
            <a:ext cx="220027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1 did not develop diabet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2 died before reaching endpoint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368D04A7-085E-44D7-9DB0-2138FB0C5798}"/>
              </a:ext>
            </a:extLst>
          </p:cNvPr>
          <p:cNvSpPr txBox="1"/>
          <p:nvPr/>
        </p:nvSpPr>
        <p:spPr>
          <a:xfrm>
            <a:off x="4600575" y="1809750"/>
            <a:ext cx="220027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2 did not develop diabetes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1AABA04E-44CC-43D5-B98C-4BFE9A01B719}"/>
              </a:ext>
            </a:extLst>
          </p:cNvPr>
          <p:cNvCxnSpPr/>
          <p:nvPr/>
        </p:nvCxnSpPr>
        <p:spPr>
          <a:xfrm>
            <a:off x="0" y="2647950"/>
            <a:ext cx="6858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51661D23-4581-4F0A-BF35-7BB76A068166}"/>
              </a:ext>
            </a:extLst>
          </p:cNvPr>
          <p:cNvSpPr txBox="1"/>
          <p:nvPr/>
        </p:nvSpPr>
        <p:spPr>
          <a:xfrm>
            <a:off x="2551778" y="2771161"/>
            <a:ext cx="1548581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/>
              <a:t>Cohort 2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xmlns="" id="{F414BD4E-5C22-435A-A927-E8BE7383F78D}"/>
              </a:ext>
            </a:extLst>
          </p:cNvPr>
          <p:cNvCxnSpPr>
            <a:cxnSpLocks/>
            <a:stCxn id="33" idx="2"/>
          </p:cNvCxnSpPr>
          <p:nvPr/>
        </p:nvCxnSpPr>
        <p:spPr>
          <a:xfrm>
            <a:off x="3326069" y="3048160"/>
            <a:ext cx="0" cy="37131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xmlns="" id="{1F82CC6F-679F-4EA9-B331-FBD468AA2F86}"/>
              </a:ext>
            </a:extLst>
          </p:cNvPr>
          <p:cNvCxnSpPr>
            <a:cxnSpLocks/>
          </p:cNvCxnSpPr>
          <p:nvPr/>
        </p:nvCxnSpPr>
        <p:spPr>
          <a:xfrm>
            <a:off x="638175" y="3438525"/>
            <a:ext cx="54102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xmlns="" id="{E2845ED6-A49C-49FE-978D-A01A35BA047E}"/>
              </a:ext>
            </a:extLst>
          </p:cNvPr>
          <p:cNvCxnSpPr>
            <a:cxnSpLocks/>
          </p:cNvCxnSpPr>
          <p:nvPr/>
        </p:nvCxnSpPr>
        <p:spPr>
          <a:xfrm>
            <a:off x="630494" y="343576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xmlns="" id="{022544E0-8BEA-4760-8BFB-BBC00B191AEF}"/>
              </a:ext>
            </a:extLst>
          </p:cNvPr>
          <p:cNvCxnSpPr>
            <a:cxnSpLocks/>
          </p:cNvCxnSpPr>
          <p:nvPr/>
        </p:nvCxnSpPr>
        <p:spPr>
          <a:xfrm>
            <a:off x="2344994" y="343576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xmlns="" id="{31D0F6BA-C1F5-4532-9A66-DCBC9FE7CE5E}"/>
              </a:ext>
            </a:extLst>
          </p:cNvPr>
          <p:cNvCxnSpPr>
            <a:cxnSpLocks/>
          </p:cNvCxnSpPr>
          <p:nvPr/>
        </p:nvCxnSpPr>
        <p:spPr>
          <a:xfrm>
            <a:off x="4335719" y="343576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xmlns="" id="{8979C74D-E6C6-4FD2-83B2-132DF05CBDCB}"/>
              </a:ext>
            </a:extLst>
          </p:cNvPr>
          <p:cNvCxnSpPr>
            <a:cxnSpLocks/>
          </p:cNvCxnSpPr>
          <p:nvPr/>
        </p:nvCxnSpPr>
        <p:spPr>
          <a:xfrm>
            <a:off x="6040694" y="343576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634BE772-5EED-403C-9660-0ABBF3A15470}"/>
              </a:ext>
            </a:extLst>
          </p:cNvPr>
          <p:cNvSpPr txBox="1"/>
          <p:nvPr/>
        </p:nvSpPr>
        <p:spPr>
          <a:xfrm>
            <a:off x="161925" y="3714750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ND BPN</a:t>
            </a:r>
          </a:p>
          <a:p>
            <a:pPr algn="ctr"/>
            <a:r>
              <a:rPr lang="en-AU" sz="1200" dirty="0"/>
              <a:t>n=5 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D53345B8-9EEB-41E0-8AE0-B6E4D2717EDF}"/>
              </a:ext>
            </a:extLst>
          </p:cNvPr>
          <p:cNvSpPr txBox="1"/>
          <p:nvPr/>
        </p:nvSpPr>
        <p:spPr>
          <a:xfrm>
            <a:off x="1809750" y="372427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D BPN</a:t>
            </a:r>
          </a:p>
          <a:p>
            <a:pPr algn="ctr"/>
            <a:r>
              <a:rPr lang="en-AU" sz="1200" dirty="0"/>
              <a:t>n=1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3F50E5C7-9F68-4BF7-BE37-C2E00DEDF63F}"/>
              </a:ext>
            </a:extLst>
          </p:cNvPr>
          <p:cNvSpPr txBox="1"/>
          <p:nvPr/>
        </p:nvSpPr>
        <p:spPr>
          <a:xfrm>
            <a:off x="3819525" y="3714750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ND BPH</a:t>
            </a:r>
          </a:p>
          <a:p>
            <a:pPr algn="ctr"/>
            <a:r>
              <a:rPr lang="en-AU" sz="1200" dirty="0"/>
              <a:t>n=1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6A7085E2-D57C-4BF8-89D3-C57536EF4418}"/>
              </a:ext>
            </a:extLst>
          </p:cNvPr>
          <p:cNvSpPr txBox="1"/>
          <p:nvPr/>
        </p:nvSpPr>
        <p:spPr>
          <a:xfrm>
            <a:off x="5448300" y="3714750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D BPH</a:t>
            </a:r>
          </a:p>
          <a:p>
            <a:pPr algn="ctr"/>
            <a:r>
              <a:rPr lang="en-AU" sz="1200" dirty="0"/>
              <a:t>n=18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F1044F34-6922-4241-B19A-9E25EABD0A03}"/>
              </a:ext>
            </a:extLst>
          </p:cNvPr>
          <p:cNvCxnSpPr>
            <a:cxnSpLocks/>
          </p:cNvCxnSpPr>
          <p:nvPr/>
        </p:nvCxnSpPr>
        <p:spPr>
          <a:xfrm>
            <a:off x="2344994" y="416919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xmlns="" id="{634113DC-7B21-4ED3-86D8-4CC2983FADF5}"/>
              </a:ext>
            </a:extLst>
          </p:cNvPr>
          <p:cNvCxnSpPr>
            <a:cxnSpLocks/>
          </p:cNvCxnSpPr>
          <p:nvPr/>
        </p:nvCxnSpPr>
        <p:spPr>
          <a:xfrm>
            <a:off x="6059744" y="416919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27B2E843-2A64-4E48-A24B-767A18A68CB0}"/>
              </a:ext>
            </a:extLst>
          </p:cNvPr>
          <p:cNvSpPr txBox="1"/>
          <p:nvPr/>
        </p:nvSpPr>
        <p:spPr>
          <a:xfrm>
            <a:off x="1352550" y="4457700"/>
            <a:ext cx="220027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2 did not develop diabete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xmlns="" id="{43DA3B05-1589-40C5-9FE4-B48226CFB8F7}"/>
              </a:ext>
            </a:extLst>
          </p:cNvPr>
          <p:cNvSpPr txBox="1"/>
          <p:nvPr/>
        </p:nvSpPr>
        <p:spPr>
          <a:xfrm>
            <a:off x="4600575" y="4448175"/>
            <a:ext cx="2200275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1 did not develop diabet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4 died before reaching endpoi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1 was sick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2 were littermates that presented with fight wounds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xmlns="" id="{4703BA38-E8B8-4541-9AE6-33DD51618CDB}"/>
              </a:ext>
            </a:extLst>
          </p:cNvPr>
          <p:cNvCxnSpPr/>
          <p:nvPr/>
        </p:nvCxnSpPr>
        <p:spPr>
          <a:xfrm>
            <a:off x="-9525" y="5762625"/>
            <a:ext cx="6858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xmlns="" id="{5BA108A5-8188-4E6B-8802-4531F6B9FF9E}"/>
              </a:ext>
            </a:extLst>
          </p:cNvPr>
          <p:cNvSpPr txBox="1"/>
          <p:nvPr/>
        </p:nvSpPr>
        <p:spPr>
          <a:xfrm>
            <a:off x="2551778" y="5904886"/>
            <a:ext cx="1548581" cy="2769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/>
              <a:t>Cohort 3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xmlns="" id="{729A3342-CCA7-406F-8B5A-9A260CA741D1}"/>
              </a:ext>
            </a:extLst>
          </p:cNvPr>
          <p:cNvCxnSpPr>
            <a:cxnSpLocks/>
            <a:stCxn id="49" idx="2"/>
          </p:cNvCxnSpPr>
          <p:nvPr/>
        </p:nvCxnSpPr>
        <p:spPr>
          <a:xfrm>
            <a:off x="3326069" y="6181885"/>
            <a:ext cx="0" cy="37131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xmlns="" id="{E9126F5C-BBE2-4286-A520-DE079F779F74}"/>
              </a:ext>
            </a:extLst>
          </p:cNvPr>
          <p:cNvCxnSpPr>
            <a:cxnSpLocks/>
          </p:cNvCxnSpPr>
          <p:nvPr/>
        </p:nvCxnSpPr>
        <p:spPr>
          <a:xfrm>
            <a:off x="638175" y="6572250"/>
            <a:ext cx="54102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xmlns="" id="{F42EC3D1-A778-459E-9CF6-620F143BE4DB}"/>
              </a:ext>
            </a:extLst>
          </p:cNvPr>
          <p:cNvCxnSpPr>
            <a:cxnSpLocks/>
          </p:cNvCxnSpPr>
          <p:nvPr/>
        </p:nvCxnSpPr>
        <p:spPr>
          <a:xfrm>
            <a:off x="630494" y="656949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xmlns="" id="{25014F2E-1E8B-4385-956E-8355076C2B48}"/>
              </a:ext>
            </a:extLst>
          </p:cNvPr>
          <p:cNvCxnSpPr>
            <a:cxnSpLocks/>
          </p:cNvCxnSpPr>
          <p:nvPr/>
        </p:nvCxnSpPr>
        <p:spPr>
          <a:xfrm>
            <a:off x="2344994" y="656949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64FDD54E-73E2-485C-8310-33944F8C6177}"/>
              </a:ext>
            </a:extLst>
          </p:cNvPr>
          <p:cNvCxnSpPr>
            <a:cxnSpLocks/>
          </p:cNvCxnSpPr>
          <p:nvPr/>
        </p:nvCxnSpPr>
        <p:spPr>
          <a:xfrm>
            <a:off x="4335719" y="656949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xmlns="" id="{66157370-576F-4108-A084-92EE40FF9A3A}"/>
              </a:ext>
            </a:extLst>
          </p:cNvPr>
          <p:cNvCxnSpPr>
            <a:cxnSpLocks/>
          </p:cNvCxnSpPr>
          <p:nvPr/>
        </p:nvCxnSpPr>
        <p:spPr>
          <a:xfrm>
            <a:off x="6040694" y="6569493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A21989B6-E1C3-4CCE-B245-F061E100181C}"/>
              </a:ext>
            </a:extLst>
          </p:cNvPr>
          <p:cNvSpPr txBox="1"/>
          <p:nvPr/>
        </p:nvSpPr>
        <p:spPr>
          <a:xfrm>
            <a:off x="161925" y="684847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ND BPN</a:t>
            </a:r>
          </a:p>
          <a:p>
            <a:pPr algn="ctr"/>
            <a:r>
              <a:rPr lang="en-AU" sz="1200" dirty="0"/>
              <a:t>n=9 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CAAD6447-860A-41E7-9BE6-74A47C8F7588}"/>
              </a:ext>
            </a:extLst>
          </p:cNvPr>
          <p:cNvSpPr txBox="1"/>
          <p:nvPr/>
        </p:nvSpPr>
        <p:spPr>
          <a:xfrm>
            <a:off x="1809750" y="6858000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D BPN</a:t>
            </a:r>
          </a:p>
          <a:p>
            <a:pPr algn="ctr"/>
            <a:r>
              <a:rPr lang="en-AU" sz="1200" dirty="0"/>
              <a:t>n=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68636ECB-1EC9-4CF8-A37C-81406462F40D}"/>
              </a:ext>
            </a:extLst>
          </p:cNvPr>
          <p:cNvSpPr txBox="1"/>
          <p:nvPr/>
        </p:nvSpPr>
        <p:spPr>
          <a:xfrm>
            <a:off x="3819525" y="684847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ND BPH</a:t>
            </a:r>
          </a:p>
          <a:p>
            <a:pPr algn="ctr"/>
            <a:r>
              <a:rPr lang="en-AU" sz="1200" dirty="0"/>
              <a:t>n=14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xmlns="" id="{8B37339E-8AD1-418C-9074-1C6F7D4C5E52}"/>
              </a:ext>
            </a:extLst>
          </p:cNvPr>
          <p:cNvSpPr txBox="1"/>
          <p:nvPr/>
        </p:nvSpPr>
        <p:spPr>
          <a:xfrm>
            <a:off x="5448300" y="6848475"/>
            <a:ext cx="101917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1200" dirty="0"/>
              <a:t>D BPH</a:t>
            </a:r>
          </a:p>
          <a:p>
            <a:pPr algn="ctr"/>
            <a:r>
              <a:rPr lang="en-AU" sz="1200" dirty="0"/>
              <a:t>n=18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xmlns="" id="{C6E40CF7-1544-4F72-A6F3-59CA15D6A5B9}"/>
              </a:ext>
            </a:extLst>
          </p:cNvPr>
          <p:cNvCxnSpPr>
            <a:cxnSpLocks/>
          </p:cNvCxnSpPr>
          <p:nvPr/>
        </p:nvCxnSpPr>
        <p:spPr>
          <a:xfrm>
            <a:off x="2344994" y="730291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xmlns="" id="{CFC81E07-CB4B-49C7-AAC0-633A8D69DC48}"/>
              </a:ext>
            </a:extLst>
          </p:cNvPr>
          <p:cNvCxnSpPr>
            <a:cxnSpLocks/>
          </p:cNvCxnSpPr>
          <p:nvPr/>
        </p:nvCxnSpPr>
        <p:spPr>
          <a:xfrm>
            <a:off x="6059744" y="7302918"/>
            <a:ext cx="0" cy="27898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4592FB5B-33B8-45FC-8A77-1CE5AC9CDF3D}"/>
              </a:ext>
            </a:extLst>
          </p:cNvPr>
          <p:cNvSpPr txBox="1"/>
          <p:nvPr/>
        </p:nvSpPr>
        <p:spPr>
          <a:xfrm>
            <a:off x="1352550" y="7591425"/>
            <a:ext cx="220027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1 did not develop diabete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9D62410E-7EE3-4F46-9C1A-D35652089111}"/>
              </a:ext>
            </a:extLst>
          </p:cNvPr>
          <p:cNvSpPr txBox="1"/>
          <p:nvPr/>
        </p:nvSpPr>
        <p:spPr>
          <a:xfrm>
            <a:off x="4600575" y="7581900"/>
            <a:ext cx="2200275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AU" sz="1200" dirty="0"/>
              <a:t>n=5 did not develop diabetes</a:t>
            </a:r>
          </a:p>
        </p:txBody>
      </p: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BA10AA5F-EA75-443F-A8DB-FC1F4978D260}"/>
              </a:ext>
            </a:extLst>
          </p:cNvPr>
          <p:cNvCxnSpPr/>
          <p:nvPr/>
        </p:nvCxnSpPr>
        <p:spPr>
          <a:xfrm>
            <a:off x="0" y="8420100"/>
            <a:ext cx="6858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096134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8607799"/>
              </p:ext>
            </p:extLst>
          </p:nvPr>
        </p:nvGraphicFramePr>
        <p:xfrm>
          <a:off x="1178168" y="480646"/>
          <a:ext cx="4572000" cy="57378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xmlns="" val="468345833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xmlns="" val="2132499998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xmlns="" val="19269365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AU" sz="135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ne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ward primers (5’ – 3’)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verse primers (5’ – 3’)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5794214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CP-1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TGTGCTGACCCCAAGAAG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TTCCGATCCAGGTTTTTA 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83318342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Fβ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AGCAACATGTGGAACTC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TCAGCAGCCGGTTACCA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6669129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GF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TGCCTACCGACTGGAAGA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TAGAACAGGCGCTCCACTCT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505510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NP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CTGCTAGACCACCTGGAG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CTTGGCTGTTATCTTCGGTACCGG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5431079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NP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CCGCTGGGAGGTCACT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AGCTTCTGCATCTTGAATTGC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675956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X1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ATGCCCAGGATCGAGGT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TGGAAGCAAAGGGAGTGA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1500650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X4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GATCACAGAAGGTCCCTAGCAG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GGCTACATGCACACCTGAGAA </a:t>
                      </a:r>
                    </a:p>
                    <a:p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5438141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47-phox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CCTGAGACATACCTGGTG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ACTTCTGCAGATACATGG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5474379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L-1β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AAATGCCACCTTTTGACAGTG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TGTGCTGCTGCGAGATTTG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869216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8S 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TTCACCATGAGGCTGAGATC</a:t>
                      </a:r>
                      <a:endParaRPr lang="en-AU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AU" sz="13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GTTGCCTGGGAAAATCC</a:t>
                      </a:r>
                      <a:endParaRPr lang="en-AU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19136166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1104899" y="6443227"/>
            <a:ext cx="472146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Table 1: m</a:t>
            </a:r>
            <a:r>
              <a:rPr lang="en-GB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RNA sequences</a:t>
            </a:r>
            <a:endParaRPr lang="en-AU" sz="1400" dirty="0"/>
          </a:p>
        </p:txBody>
      </p:sp>
    </p:spTree>
    <p:extLst>
      <p:ext uri="{BB962C8B-B14F-4D97-AF65-F5344CB8AC3E}">
        <p14:creationId xmlns:p14="http://schemas.microsoft.com/office/powerpoint/2010/main" val="2553932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793</TotalTime>
  <Words>631</Words>
  <Application>Microsoft Macintosh PowerPoint</Application>
  <PresentationFormat>Widescreen</PresentationFormat>
  <Paragraphs>116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Calibri</vt:lpstr>
      <vt:lpstr>Calibri Light</vt:lpstr>
      <vt:lpstr>Times New Roman</vt:lpstr>
      <vt:lpstr>Arial</vt:lpstr>
      <vt:lpstr>Office Theme</vt:lpstr>
      <vt:lpstr>Prism 9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peeta Sharma</dc:creator>
  <cp:lastModifiedBy>Microsoft Office User</cp:lastModifiedBy>
  <cp:revision>145</cp:revision>
  <cp:lastPrinted>2022-09-13T23:59:42Z</cp:lastPrinted>
  <dcterms:created xsi:type="dcterms:W3CDTF">2021-01-07T03:56:05Z</dcterms:created>
  <dcterms:modified xsi:type="dcterms:W3CDTF">2023-05-19T04:22:52Z</dcterms:modified>
</cp:coreProperties>
</file>